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8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8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wmf" ContentType="image/x-wmf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</p:sldIdLst>
  <p:sldSz cx="6858000" cy="9144000"/>
  <p:notesSz cx="6832600" cy="99790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32800" cy="9979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60640" cy="49860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71800" y="-360"/>
            <a:ext cx="2960640" cy="49860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300" spc="-1" strike="noStrike">
                <a:solidFill>
                  <a:srgbClr val="000000"/>
                </a:solidFill>
                <a:latin typeface="Arial"/>
                <a:ea typeface="SimSu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A2F4FC-B2F1-4432-BB28-25B1F317404F}" type="datetime">
              <a:rPr b="0" lang="en-US" sz="1300" spc="-1" strike="noStrike">
                <a:solidFill>
                  <a:srgbClr val="000000"/>
                </a:solidFill>
                <a:latin typeface="Arial"/>
                <a:ea typeface="SimSun"/>
              </a:rPr>
              <a:t>08/29/26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14560" y="749160"/>
            <a:ext cx="2805120" cy="3741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3240" rIns="9324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2560" y="4739760"/>
            <a:ext cx="5469120" cy="448956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78440"/>
            <a:ext cx="2960640" cy="49860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71800" y="9478440"/>
            <a:ext cx="2960640" cy="49860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300" spc="-1" strike="noStrike">
                <a:solidFill>
                  <a:srgbClr val="000000"/>
                </a:solidFill>
                <a:latin typeface="Arial"/>
                <a:ea typeface="SimSu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E129C5-02E5-4642-BBBF-DACFA3DA5DD0}" type="slidenum">
              <a:rPr b="0" lang="en-US" sz="1300" spc="-1" strike="noStrike">
                <a:solidFill>
                  <a:srgbClr val="000000"/>
                </a:solidFill>
                <a:latin typeface="Arial"/>
                <a:ea typeface="SimSun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sldImg"/>
          </p:nvPr>
        </p:nvSpPr>
        <p:spPr>
          <a:xfrm>
            <a:off x="2014560" y="749160"/>
            <a:ext cx="2805120" cy="3741840"/>
          </a:xfrm>
          <a:prstGeom prst="rect">
            <a:avLst/>
          </a:prstGeom>
          <a:ln w="0">
            <a:noFill/>
          </a:ln>
        </p:spPr>
      </p:sp>
      <p:sp>
        <p:nvSpPr>
          <p:cNvPr id="136" name="PlaceHolder 2"/>
          <p:cNvSpPr>
            <a:spLocks noGrp="1"/>
          </p:cNvSpPr>
          <p:nvPr>
            <p:ph type="body"/>
          </p:nvPr>
        </p:nvSpPr>
        <p:spPr>
          <a:xfrm>
            <a:off x="682560" y="4739760"/>
            <a:ext cx="5469120" cy="448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Slide Number Placeholder 3"/>
          <p:cNvSpPr/>
          <p:nvPr/>
        </p:nvSpPr>
        <p:spPr>
          <a:xfrm>
            <a:off x="3871800" y="9478800"/>
            <a:ext cx="2960640" cy="49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B37A57-1F85-4F8E-B04B-C9BD236E4961}" type="slidenum">
              <a:rPr b="0" lang="en-US" sz="1300" spc="-1" strike="noStrike">
                <a:solidFill>
                  <a:srgbClr val="000000"/>
                </a:solidFill>
                <a:latin typeface="Arial"/>
                <a:ea typeface="SimSun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sldImg"/>
          </p:nvPr>
        </p:nvSpPr>
        <p:spPr>
          <a:xfrm>
            <a:off x="2014560" y="749160"/>
            <a:ext cx="2805120" cy="3741840"/>
          </a:xfrm>
          <a:prstGeom prst="rect">
            <a:avLst/>
          </a:prstGeom>
          <a:ln w="0">
            <a:noFill/>
          </a:ln>
        </p:spPr>
      </p:sp>
      <p:sp>
        <p:nvSpPr>
          <p:cNvPr id="139" name="PlaceHolder 2"/>
          <p:cNvSpPr>
            <a:spLocks noGrp="1"/>
          </p:cNvSpPr>
          <p:nvPr>
            <p:ph type="body"/>
          </p:nvPr>
        </p:nvSpPr>
        <p:spPr>
          <a:xfrm>
            <a:off x="682560" y="4739760"/>
            <a:ext cx="5469120" cy="448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Slide Number Placeholder 3"/>
          <p:cNvSpPr/>
          <p:nvPr/>
        </p:nvSpPr>
        <p:spPr>
          <a:xfrm>
            <a:off x="3871800" y="9478800"/>
            <a:ext cx="2960640" cy="49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AA6D8A-3496-4A36-9D88-26994E5ED365}" type="slidenum">
              <a:rPr b="0" lang="en-US" sz="1300" spc="-1" strike="noStrike">
                <a:solidFill>
                  <a:srgbClr val="000000"/>
                </a:solidFill>
                <a:latin typeface="Arial"/>
                <a:ea typeface="SimSun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82919E-4873-4115-9922-A65B95F7AE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B3349C-BB81-4642-8F55-C4AEF0D40F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9E464B-9F1A-411D-994C-A5F4030C44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1B0507-97D1-469A-BC8F-AD5F380ED5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9764C4-BE0A-4E37-B375-2A0AAF8B83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739AB7-6B0C-4CE3-9E7D-0F5C3AB618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487507-4348-428E-8CAF-67826E8174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05ABD8-32FB-4E09-B5C0-167C7C6E06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E02386-16A2-4CF3-9B8E-1D7815DCBC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458F5-C203-4B21-8D07-354CFC4681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8BC720-A149-4808-AAE1-DDC94A3E85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5052AB-FB3B-4A82-8BB2-17D901A2F1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SimSu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247E9B-B1B3-4948-8C92-EFE60FFD744C}" type="slidenum">
              <a:rPr b="0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hyperlink" Target="http://rice.plantbiology.msu.edu/" TargetMode="External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352440" y="237960"/>
            <a:ext cx="6200640" cy="6956640"/>
          </a:xfrm>
          <a:prstGeom prst="rect">
            <a:avLst/>
          </a:prstGeom>
          <a:ln w="0">
            <a:noFill/>
          </a:ln>
        </p:spPr>
      </p:pic>
      <p:sp>
        <p:nvSpPr>
          <p:cNvPr id="49" name="TextBox 4"/>
          <p:cNvSpPr/>
          <p:nvPr/>
        </p:nvSpPr>
        <p:spPr>
          <a:xfrm>
            <a:off x="123840" y="7391520"/>
            <a:ext cx="6504120" cy="160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.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alysis of the ubiquitinated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site-containing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proteins in rice from published studie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)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KaiTi"/>
              </a:rPr>
              <a:t>Venn diagram of the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ubiquitinated site-containing proteins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identified by the K-Ɛ-GG antibody enrichment method followed by mass spectrometry during rice young leaves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with or without PAMP treatment,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seed germination, and panicles development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, respectively. 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) Gene Ontology enrichment of ubiquitinated proteins from multiple ubiquitylomes. The size of blue dots represents the number of ubiquitinated proteins involved in biological processes. 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c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) Literature reported ubiquitinated proteins and interacting E3 ligases involved in multiple biological processes. Hexagon represents ubiquitinated proteins and circle represents E3 ligase. Different colors represent the different kinds of E3s. 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d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) Overlapping of ubiquitinated proteins from the literature in c and multiple ubiquitylome analysis in a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TextBox 19"/>
          <p:cNvSpPr/>
          <p:nvPr/>
        </p:nvSpPr>
        <p:spPr>
          <a:xfrm>
            <a:off x="147600" y="6248520"/>
            <a:ext cx="662940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9. Transcript level of </a:t>
            </a: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sPAL1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individual overexpression lines</a:t>
            </a: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t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e editing types of </a:t>
            </a: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sFBK16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AutoNum type="alphaL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nscript level of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sPAL1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 two representative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sPAL1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overexpression lines and wild type.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The </a:t>
            </a:r>
            <a:r>
              <a:rPr b="0" lang="en-US" sz="1100" spc="-1" strike="noStrike">
                <a:solidFill>
                  <a:srgbClr val="444444"/>
                </a:solidFill>
                <a:latin typeface="Times New Roman"/>
                <a:ea typeface="Times New Roman"/>
              </a:rPr>
              <a:t>significance</a:t>
            </a:r>
            <a:r>
              <a:rPr b="0" lang="en-US" sz="800" spc="-1" strike="noStrike">
                <a:solidFill>
                  <a:srgbClr val="444444"/>
                </a:solidFill>
                <a:latin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analysis was performed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according to Student’s t test (**p &lt; 0.01).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Times New Roman"/>
              <a:buAutoNum type="alphaL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diting types of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sFBK16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Picture 1" descr=""/>
          <p:cNvPicPr/>
          <p:nvPr/>
        </p:nvPicPr>
        <p:blipFill>
          <a:blip r:embed="rId1"/>
          <a:stretch/>
        </p:blipFill>
        <p:spPr>
          <a:xfrm>
            <a:off x="762120" y="658800"/>
            <a:ext cx="5022720" cy="4473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TextBox 19"/>
          <p:cNvSpPr/>
          <p:nvPr/>
        </p:nvSpPr>
        <p:spPr>
          <a:xfrm>
            <a:off x="239760" y="4648320"/>
            <a:ext cx="637704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0.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Degradation assay of OsPAL5 and OsPAL6 by OsFBK16 </a:t>
            </a: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in vivo</a:t>
            </a: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r>
              <a:rPr b="1" i="1" lang="zh-CN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Co-expression of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OsPAL5-GFP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or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OsPAL6-GFP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and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OsFBK16-HA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or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GUS-HA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in rice protoplasts. Samples were collected and total protein was extracted. The protein abundance of OsPAL5 and OsPAL6 were detected by immunoblotting using anti-GFP antibody, and OsFBK16 and GUS were detected using anti-HA antibody,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2" name="图片 2" descr=""/>
          <p:cNvPicPr/>
          <p:nvPr/>
        </p:nvPicPr>
        <p:blipFill>
          <a:blip r:embed="rId1"/>
          <a:stretch/>
        </p:blipFill>
        <p:spPr>
          <a:xfrm>
            <a:off x="1828800" y="762120"/>
            <a:ext cx="2865600" cy="336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TextBox 19"/>
          <p:cNvSpPr/>
          <p:nvPr/>
        </p:nvSpPr>
        <p:spPr>
          <a:xfrm>
            <a:off x="388800" y="5189400"/>
            <a:ext cx="608040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1. Transcript level of </a:t>
            </a: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sPAL6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in individual overexpression line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nscript level of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PAL6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 two representative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sPAL6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overexpression lines and wild type.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The </a:t>
            </a:r>
            <a:r>
              <a:rPr b="0" lang="en-US" sz="1100" spc="-1" strike="noStrike">
                <a:solidFill>
                  <a:srgbClr val="444444"/>
                </a:solidFill>
                <a:latin typeface="Times New Roman"/>
                <a:ea typeface="Times New Roman"/>
              </a:rPr>
              <a:t>significance</a:t>
            </a:r>
            <a:r>
              <a:rPr b="0" lang="en-US" sz="800" spc="-1" strike="noStrike">
                <a:solidFill>
                  <a:srgbClr val="444444"/>
                </a:solidFill>
                <a:latin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analysis was performed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according to Student’s t test (**p &lt; 0.01).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4" name="Picture 3" descr=""/>
          <p:cNvPicPr/>
          <p:nvPr/>
        </p:nvPicPr>
        <p:blipFill>
          <a:blip r:embed="rId1"/>
          <a:stretch/>
        </p:blipFill>
        <p:spPr>
          <a:xfrm>
            <a:off x="1905120" y="1523880"/>
            <a:ext cx="2819160" cy="2975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内容占位符 4" descr=""/>
          <p:cNvPicPr/>
          <p:nvPr/>
        </p:nvPicPr>
        <p:blipFill>
          <a:blip r:embed="rId1"/>
          <a:stretch/>
        </p:blipFill>
        <p:spPr>
          <a:xfrm>
            <a:off x="177840" y="990720"/>
            <a:ext cx="6502320" cy="5106960"/>
          </a:xfrm>
          <a:prstGeom prst="rect">
            <a:avLst/>
          </a:prstGeom>
          <a:ln w="0">
            <a:noFill/>
          </a:ln>
        </p:spPr>
      </p:pic>
      <p:sp>
        <p:nvSpPr>
          <p:cNvPr id="51" name="文本框 6"/>
          <p:cNvSpPr/>
          <p:nvPr/>
        </p:nvSpPr>
        <p:spPr>
          <a:xfrm>
            <a:off x="177840" y="6553080"/>
            <a:ext cx="668016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.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Location of all E3 ligase encoding genes on the rice chromosome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localization of 1515 E3 ligase encoding genes are refer to MSU. V7.0.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se genes are distributed in 12 rice chromosome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ng Perl SVG module,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4"/>
          <p:cNvSpPr/>
          <p:nvPr/>
        </p:nvSpPr>
        <p:spPr>
          <a:xfrm>
            <a:off x="304920" y="3505320"/>
            <a:ext cx="640080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3. Different types of ubiquitin E3 ligase-encoding genes in rice and the number of RT-PCR cloned and chemically synthesized E3 genes in this study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mber represents total E3 ligase-encoding genes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from </a:t>
            </a:r>
            <a:r>
              <a:rPr b="0" lang="en-US" sz="1100" spc="-1" strike="noStrike" u="sng">
                <a:solidFill>
                  <a:srgbClr val="009999"/>
                </a:solidFill>
                <a:uFillTx/>
                <a:latin typeface="Times New Roman"/>
                <a:ea typeface="SimSun"/>
                <a:hlinkClick r:id="rId1"/>
              </a:rPr>
              <a:t>http://rice.plantbiology.msu.edu/</a:t>
            </a:r>
            <a:r>
              <a:rPr b="0" lang="en-US" sz="1100" spc="-1" strike="noStrike" u="sng">
                <a:solidFill>
                  <a:srgbClr val="000000"/>
                </a:solidFill>
                <a:uFillTx/>
                <a:latin typeface="Times New Roman"/>
                <a:ea typeface="SimSun"/>
              </a:rPr>
              <a:t>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ailed means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not successfully PCR cloned or </a:t>
            </a:r>
            <a:r>
              <a:rPr b="0" lang="en-US" sz="1100" spc="-1" strike="noStrike">
                <a:solidFill>
                  <a:srgbClr val="333333"/>
                </a:solidFill>
                <a:latin typeface="Times New Roman"/>
                <a:ea typeface="SimSun"/>
              </a:rPr>
              <a:t>chemically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synthesized due to their huge sizes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3" descr=""/>
          <p:cNvPicPr/>
          <p:nvPr/>
        </p:nvPicPr>
        <p:blipFill>
          <a:blip r:embed="rId2"/>
          <a:stretch/>
        </p:blipFill>
        <p:spPr>
          <a:xfrm>
            <a:off x="771480" y="1295280"/>
            <a:ext cx="5315040" cy="1974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79"/>
          <p:cNvSpPr/>
          <p:nvPr/>
        </p:nvSpPr>
        <p:spPr>
          <a:xfrm>
            <a:off x="196920" y="7985160"/>
            <a:ext cx="654192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4.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firmation of the interaction between OsUBC14 and its candidate E3s.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GADT7 plasmid (AD) harboring 63 candidate E3s individually and pGBKT7 plasmid (BD) harboring OsUBC14 were co-transformed into AH109 strain for interaction confirmation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TIX-Regular"/>
              </a:rPr>
              <a:t>DDO, </a:t>
            </a:r>
            <a:r>
              <a:rPr b="0" lang="en-US" sz="1100" spc="-1" strike="noStrike">
                <a:solidFill>
                  <a:srgbClr val="333333"/>
                </a:solidFill>
                <a:latin typeface="Times New Roman"/>
                <a:ea typeface="SimSun"/>
              </a:rPr>
              <a:t>SD-Leu-Trp,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TIX-Regular"/>
              </a:rPr>
              <a:t> QDO, SD</a:t>
            </a:r>
            <a:r>
              <a:rPr b="0" lang="en-US" sz="1100" spc="-1" strike="noStrike">
                <a:solidFill>
                  <a:srgbClr val="333333"/>
                </a:solidFill>
                <a:latin typeface="Times New Roman"/>
                <a:ea typeface="SimSun"/>
              </a:rPr>
              <a:t>-Leu-Trp-His-Ad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3" descr=""/>
          <p:cNvPicPr/>
          <p:nvPr/>
        </p:nvPicPr>
        <p:blipFill>
          <a:blip r:embed="rId1"/>
          <a:stretch/>
        </p:blipFill>
        <p:spPr>
          <a:xfrm>
            <a:off x="115920" y="304920"/>
            <a:ext cx="6584760" cy="757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1" descr=""/>
          <p:cNvPicPr/>
          <p:nvPr/>
        </p:nvPicPr>
        <p:blipFill>
          <a:blip r:embed="rId1"/>
          <a:stretch/>
        </p:blipFill>
        <p:spPr>
          <a:xfrm>
            <a:off x="136440" y="152280"/>
            <a:ext cx="6492960" cy="7956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"/>
          <p:cNvSpPr txBox="1"/>
          <p:nvPr/>
        </p:nvSpPr>
        <p:spPr>
          <a:xfrm>
            <a:off x="114120" y="4799160"/>
            <a:ext cx="6476760" cy="31240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>
              <a:lnSpc>
                <a:spcPct val="100000"/>
              </a:lnSpc>
              <a:spcBef>
                <a:spcPts val="2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5. E3 ubiquitin ligase activity of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sRING77,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sRING113,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OsPUB28, OsPUB46, OsPUB49 and OsPUB69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vitro.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spcBef>
                <a:spcPts val="2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-b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vitro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3 ubiquitin ligase activity assay of OsRING77 or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sRING113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. T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he ubiquitination reaction mixtures containing E1 (wheat E1), E2 (AtUBC8), 2 </a:t>
            </a:r>
            <a:r>
              <a:rPr b="0" lang="en-US" sz="1100" spc="-1" strike="noStrike">
                <a:solidFill>
                  <a:srgbClr val="333333"/>
                </a:solidFill>
                <a:latin typeface="Times New Roman"/>
                <a:ea typeface="SimSun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g/</a:t>
            </a:r>
            <a:r>
              <a:rPr b="0" lang="en-US" sz="1100" spc="-1" strike="noStrike">
                <a:solidFill>
                  <a:srgbClr val="333333"/>
                </a:solidFill>
                <a:latin typeface="Times New Roman"/>
                <a:ea typeface="SimSun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L ubiquitin, purified MBP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OsRING77 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) or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BP-OsRING113 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were mixed in a 1</a:t>
            </a:r>
            <a:r>
              <a:rPr b="0" lang="en-US" sz="1100" spc="-1" strike="noStrike">
                <a:solidFill>
                  <a:srgbClr val="666666"/>
                </a:solidFill>
                <a:latin typeface="Times New Roman"/>
                <a:ea typeface="SimSun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×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reaction buffer (50 mM Tris-HCl, pH 7.4, 10 mM MgCl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Times New Roman"/>
                <a:ea typeface="SimSun"/>
              </a:rPr>
              <a:t>2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, 5 mM ATP and 2 mM DTT). The reactions were incubated at 30 ℃ for 2 h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series of negative controls lacking E1, E2, E3, or ubiquitin was used. The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in vitro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E3 ligase activity were determined by anti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Ub and anti-MBP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spcBef>
                <a:spcPts val="2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c-f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)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In vitro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E3 ubiquitin ligase activity assay of OsPUB28, OsPUB46, OsPUB49 and OsPUB69. Purified MBP-OsPUB46, MBP-OsPUB28, MBP-OsPUB69 and MBP-OsPUB49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as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preincubated in the rice total extract. The ubiquitination reaction mixtures containing E1 (wheat E1), E2 (AtUBC8), 2 μg/μL ubiquitin and preincubated MBP-OsPUB46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were mixed in a 1 × reaction buffer (50 mM Tris-HCl, pH 7.4, 10 mM MgCl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Times New Roman"/>
                <a:ea typeface="SimSun"/>
              </a:rPr>
              <a:t>2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, 5 mM ATP and 2 mM DTT). The reactions were incubated at 30 ℃ for 2 h. The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in vitro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E3 ligase activity were determined by anti-Ub and anti-MBP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275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文本框 122"/>
          <p:cNvSpPr/>
          <p:nvPr/>
        </p:nvSpPr>
        <p:spPr>
          <a:xfrm>
            <a:off x="3537000" y="853920"/>
            <a:ext cx="119520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E1+ E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BP-OsPUB6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U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文本框 22"/>
          <p:cNvSpPr/>
          <p:nvPr/>
        </p:nvSpPr>
        <p:spPr>
          <a:xfrm>
            <a:off x="5100480" y="1216080"/>
            <a:ext cx="615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直接连接符 24"/>
          <p:cNvSpPr/>
          <p:nvPr/>
        </p:nvSpPr>
        <p:spPr>
          <a:xfrm>
            <a:off x="5291280" y="155592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文本框 25"/>
          <p:cNvSpPr/>
          <p:nvPr/>
        </p:nvSpPr>
        <p:spPr>
          <a:xfrm>
            <a:off x="5121360" y="1407960"/>
            <a:ext cx="617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17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直接连接符 26"/>
          <p:cNvSpPr/>
          <p:nvPr/>
        </p:nvSpPr>
        <p:spPr>
          <a:xfrm>
            <a:off x="5291280" y="169560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文本框 27"/>
          <p:cNvSpPr/>
          <p:nvPr/>
        </p:nvSpPr>
        <p:spPr>
          <a:xfrm>
            <a:off x="5121360" y="1739880"/>
            <a:ext cx="617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直接连接符 28"/>
          <p:cNvSpPr/>
          <p:nvPr/>
        </p:nvSpPr>
        <p:spPr>
          <a:xfrm>
            <a:off x="5291280" y="189216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文本框 29"/>
          <p:cNvSpPr/>
          <p:nvPr/>
        </p:nvSpPr>
        <p:spPr>
          <a:xfrm>
            <a:off x="5311800" y="1973160"/>
            <a:ext cx="363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7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直接连接符 30"/>
          <p:cNvSpPr/>
          <p:nvPr/>
        </p:nvSpPr>
        <p:spPr>
          <a:xfrm>
            <a:off x="5291280" y="227160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文本框 31"/>
          <p:cNvSpPr/>
          <p:nvPr/>
        </p:nvSpPr>
        <p:spPr>
          <a:xfrm>
            <a:off x="5295960" y="2336760"/>
            <a:ext cx="384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直接连接符 33"/>
          <p:cNvSpPr/>
          <p:nvPr/>
        </p:nvSpPr>
        <p:spPr>
          <a:xfrm>
            <a:off x="5291280" y="247176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直接连接符 35"/>
          <p:cNvSpPr/>
          <p:nvPr/>
        </p:nvSpPr>
        <p:spPr>
          <a:xfrm>
            <a:off x="5291280" y="209880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文本框 36"/>
          <p:cNvSpPr/>
          <p:nvPr/>
        </p:nvSpPr>
        <p:spPr>
          <a:xfrm>
            <a:off x="5286240" y="2155680"/>
            <a:ext cx="393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5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文本框 49"/>
          <p:cNvSpPr/>
          <p:nvPr/>
        </p:nvSpPr>
        <p:spPr>
          <a:xfrm>
            <a:off x="4121280" y="1854360"/>
            <a:ext cx="741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α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-U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文本框 55"/>
          <p:cNvSpPr/>
          <p:nvPr/>
        </p:nvSpPr>
        <p:spPr>
          <a:xfrm>
            <a:off x="5121360" y="1550880"/>
            <a:ext cx="617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13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文本框 58"/>
          <p:cNvSpPr/>
          <p:nvPr/>
        </p:nvSpPr>
        <p:spPr>
          <a:xfrm>
            <a:off x="4656240" y="868320"/>
            <a:ext cx="32544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br>
              <a:rPr sz="1100"/>
            </a:b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文本框 59"/>
          <p:cNvSpPr/>
          <p:nvPr/>
        </p:nvSpPr>
        <p:spPr>
          <a:xfrm>
            <a:off x="4836960" y="870120"/>
            <a:ext cx="32544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br>
              <a:rPr sz="1100"/>
            </a:b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文本框 60"/>
          <p:cNvSpPr/>
          <p:nvPr/>
        </p:nvSpPr>
        <p:spPr>
          <a:xfrm>
            <a:off x="5040360" y="870120"/>
            <a:ext cx="32544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br>
              <a:rPr sz="1100"/>
            </a:b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文本框 76"/>
          <p:cNvSpPr/>
          <p:nvPr/>
        </p:nvSpPr>
        <p:spPr>
          <a:xfrm>
            <a:off x="4122720" y="2862360"/>
            <a:ext cx="743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α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-MB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直接连接符 87"/>
          <p:cNvSpPr/>
          <p:nvPr/>
        </p:nvSpPr>
        <p:spPr>
          <a:xfrm>
            <a:off x="5291280" y="263700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文本框 90"/>
          <p:cNvSpPr/>
          <p:nvPr/>
        </p:nvSpPr>
        <p:spPr>
          <a:xfrm>
            <a:off x="5243400" y="2846520"/>
            <a:ext cx="441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7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文本框 92"/>
          <p:cNvSpPr/>
          <p:nvPr/>
        </p:nvSpPr>
        <p:spPr>
          <a:xfrm>
            <a:off x="5226120" y="313380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直接连接符 94"/>
          <p:cNvSpPr/>
          <p:nvPr/>
        </p:nvSpPr>
        <p:spPr>
          <a:xfrm>
            <a:off x="5276880" y="3265560"/>
            <a:ext cx="92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直接连接符 96"/>
          <p:cNvSpPr/>
          <p:nvPr/>
        </p:nvSpPr>
        <p:spPr>
          <a:xfrm>
            <a:off x="5291280" y="297036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文本框 100"/>
          <p:cNvSpPr/>
          <p:nvPr/>
        </p:nvSpPr>
        <p:spPr>
          <a:xfrm>
            <a:off x="5121360" y="2513160"/>
            <a:ext cx="617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图片 2" descr=""/>
          <p:cNvPicPr/>
          <p:nvPr/>
        </p:nvPicPr>
        <p:blipFill>
          <a:blip r:embed="rId1"/>
          <a:srcRect l="31477" t="42063" r="54097" b="28968"/>
          <a:stretch/>
        </p:blipFill>
        <p:spPr>
          <a:xfrm>
            <a:off x="4703760" y="2590920"/>
            <a:ext cx="563400" cy="77472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pic>
        <p:nvPicPr>
          <p:cNvPr id="84" name="图片 4" descr=""/>
          <p:cNvPicPr/>
          <p:nvPr/>
        </p:nvPicPr>
        <p:blipFill>
          <a:blip r:embed="rId2"/>
          <a:srcRect l="69451" t="28894" r="16667" b="34157"/>
          <a:stretch/>
        </p:blipFill>
        <p:spPr>
          <a:xfrm>
            <a:off x="4708440" y="1504800"/>
            <a:ext cx="558720" cy="101124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grpSp>
        <p:nvGrpSpPr>
          <p:cNvPr id="85" name="Group 1"/>
          <p:cNvGrpSpPr/>
          <p:nvPr/>
        </p:nvGrpSpPr>
        <p:grpSpPr>
          <a:xfrm>
            <a:off x="685800" y="870120"/>
            <a:ext cx="2197080" cy="3188520"/>
            <a:chOff x="685800" y="870120"/>
            <a:chExt cx="2197080" cy="3188520"/>
          </a:xfrm>
        </p:grpSpPr>
        <p:grpSp>
          <p:nvGrpSpPr>
            <p:cNvPr id="86" name="组合 1"/>
            <p:cNvGrpSpPr/>
            <p:nvPr/>
          </p:nvGrpSpPr>
          <p:grpSpPr>
            <a:xfrm>
              <a:off x="993600" y="870120"/>
              <a:ext cx="1889280" cy="3188520"/>
              <a:chOff x="993600" y="870120"/>
              <a:chExt cx="1889280" cy="3188520"/>
            </a:xfrm>
          </p:grpSpPr>
          <p:sp>
            <p:nvSpPr>
              <p:cNvPr id="87" name="直接连接符 20"/>
              <p:cNvSpPr/>
              <p:nvPr/>
            </p:nvSpPr>
            <p:spPr>
              <a:xfrm>
                <a:off x="2433600" y="2828880"/>
                <a:ext cx="90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文本框 22"/>
              <p:cNvSpPr/>
              <p:nvPr/>
            </p:nvSpPr>
            <p:spPr>
              <a:xfrm>
                <a:off x="2241720" y="1186560"/>
                <a:ext cx="615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kDa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直接连接符 23"/>
              <p:cNvSpPr/>
              <p:nvPr/>
            </p:nvSpPr>
            <p:spPr>
              <a:xfrm>
                <a:off x="2433600" y="2538360"/>
                <a:ext cx="90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直接连接符 24"/>
              <p:cNvSpPr/>
              <p:nvPr/>
            </p:nvSpPr>
            <p:spPr>
              <a:xfrm>
                <a:off x="2433600" y="1565280"/>
                <a:ext cx="90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文本框 25"/>
              <p:cNvSpPr/>
              <p:nvPr/>
            </p:nvSpPr>
            <p:spPr>
              <a:xfrm>
                <a:off x="2264040" y="1428120"/>
                <a:ext cx="615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7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直接连接符 26"/>
              <p:cNvSpPr/>
              <p:nvPr/>
            </p:nvSpPr>
            <p:spPr>
              <a:xfrm>
                <a:off x="2433600" y="1704960"/>
                <a:ext cx="90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文本框 27"/>
              <p:cNvSpPr/>
              <p:nvPr/>
            </p:nvSpPr>
            <p:spPr>
              <a:xfrm>
                <a:off x="2264040" y="1750320"/>
                <a:ext cx="615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直接连接符 28"/>
              <p:cNvSpPr/>
              <p:nvPr/>
            </p:nvSpPr>
            <p:spPr>
              <a:xfrm>
                <a:off x="2433600" y="1901880"/>
                <a:ext cx="90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文本框 29"/>
              <p:cNvSpPr/>
              <p:nvPr/>
            </p:nvSpPr>
            <p:spPr>
              <a:xfrm>
                <a:off x="2452680" y="1982160"/>
                <a:ext cx="363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7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直接连接符 30"/>
              <p:cNvSpPr/>
              <p:nvPr/>
            </p:nvSpPr>
            <p:spPr>
              <a:xfrm>
                <a:off x="2433600" y="2281320"/>
                <a:ext cx="90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文本框 32"/>
              <p:cNvSpPr/>
              <p:nvPr/>
            </p:nvSpPr>
            <p:spPr>
              <a:xfrm>
                <a:off x="2424240" y="2927160"/>
                <a:ext cx="3920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文本框 34"/>
              <p:cNvSpPr/>
              <p:nvPr/>
            </p:nvSpPr>
            <p:spPr>
              <a:xfrm>
                <a:off x="2430720" y="2401560"/>
                <a:ext cx="4032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直接连接符 35"/>
              <p:cNvSpPr/>
              <p:nvPr/>
            </p:nvSpPr>
            <p:spPr>
              <a:xfrm>
                <a:off x="2433600" y="2108160"/>
                <a:ext cx="90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文本框 36"/>
              <p:cNvSpPr/>
              <p:nvPr/>
            </p:nvSpPr>
            <p:spPr>
              <a:xfrm>
                <a:off x="2428920" y="2164680"/>
                <a:ext cx="3920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文本框 49"/>
              <p:cNvSpPr/>
              <p:nvPr/>
            </p:nvSpPr>
            <p:spPr>
              <a:xfrm>
                <a:off x="1188720" y="2322720"/>
                <a:ext cx="741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l-GR" sz="11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α</a:t>
                </a: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-Ub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直接连接符 50"/>
              <p:cNvSpPr/>
              <p:nvPr/>
            </p:nvSpPr>
            <p:spPr>
              <a:xfrm>
                <a:off x="2433600" y="3062520"/>
                <a:ext cx="90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文本框 183"/>
              <p:cNvSpPr/>
              <p:nvPr/>
            </p:nvSpPr>
            <p:spPr>
              <a:xfrm>
                <a:off x="993600" y="2876760"/>
                <a:ext cx="741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Free Ub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文本框 54"/>
              <p:cNvSpPr/>
              <p:nvPr/>
            </p:nvSpPr>
            <p:spPr>
              <a:xfrm>
                <a:off x="2463840" y="2692080"/>
                <a:ext cx="3697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文本框 55"/>
              <p:cNvSpPr/>
              <p:nvPr/>
            </p:nvSpPr>
            <p:spPr>
              <a:xfrm>
                <a:off x="2264040" y="1559880"/>
                <a:ext cx="615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3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文本框 189"/>
              <p:cNvSpPr/>
              <p:nvPr/>
            </p:nvSpPr>
            <p:spPr>
              <a:xfrm>
                <a:off x="1788840" y="870120"/>
                <a:ext cx="325440" cy="596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br>
                  <a:rPr sz="1100"/>
                </a:b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文本框 190"/>
              <p:cNvSpPr/>
              <p:nvPr/>
            </p:nvSpPr>
            <p:spPr>
              <a:xfrm>
                <a:off x="2017800" y="871560"/>
                <a:ext cx="325440" cy="596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br>
                  <a:rPr sz="1100"/>
                </a:b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文本框 191"/>
              <p:cNvSpPr/>
              <p:nvPr/>
            </p:nvSpPr>
            <p:spPr>
              <a:xfrm>
                <a:off x="2170080" y="871560"/>
                <a:ext cx="325440" cy="596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br>
                  <a:rPr sz="1100"/>
                </a:b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文本框 76"/>
              <p:cNvSpPr/>
              <p:nvPr/>
            </p:nvSpPr>
            <p:spPr>
              <a:xfrm>
                <a:off x="1187280" y="3405240"/>
                <a:ext cx="7430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l-GR" sz="11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α</a:t>
                </a: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-MBP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直接连接符 87"/>
              <p:cNvSpPr/>
              <p:nvPr/>
            </p:nvSpPr>
            <p:spPr>
              <a:xfrm>
                <a:off x="2427480" y="3294000"/>
                <a:ext cx="90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文本框 88"/>
              <p:cNvSpPr/>
              <p:nvPr/>
            </p:nvSpPr>
            <p:spPr>
              <a:xfrm>
                <a:off x="2399040" y="3332160"/>
                <a:ext cx="483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直接连接符 89"/>
              <p:cNvSpPr/>
              <p:nvPr/>
            </p:nvSpPr>
            <p:spPr>
              <a:xfrm>
                <a:off x="2427480" y="3470400"/>
                <a:ext cx="918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文本框 90"/>
              <p:cNvSpPr/>
              <p:nvPr/>
            </p:nvSpPr>
            <p:spPr>
              <a:xfrm>
                <a:off x="2384640" y="3571920"/>
                <a:ext cx="442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7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文本框 92"/>
              <p:cNvSpPr/>
              <p:nvPr/>
            </p:nvSpPr>
            <p:spPr>
              <a:xfrm>
                <a:off x="2367000" y="3797280"/>
                <a:ext cx="448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直接连接符 94"/>
              <p:cNvSpPr/>
              <p:nvPr/>
            </p:nvSpPr>
            <p:spPr>
              <a:xfrm>
                <a:off x="2427480" y="3922920"/>
                <a:ext cx="918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直接连接符 96"/>
              <p:cNvSpPr/>
              <p:nvPr/>
            </p:nvSpPr>
            <p:spPr>
              <a:xfrm>
                <a:off x="2427480" y="3694320"/>
                <a:ext cx="90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文本框 100"/>
              <p:cNvSpPr/>
              <p:nvPr/>
            </p:nvSpPr>
            <p:spPr>
              <a:xfrm>
                <a:off x="2435400" y="3144600"/>
                <a:ext cx="442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3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18" name="图片 2" descr=""/>
              <p:cNvPicPr/>
              <p:nvPr/>
            </p:nvPicPr>
            <p:blipFill>
              <a:blip r:embed="rId3"/>
              <a:srcRect l="67138" t="25493" r="17775" b="12835"/>
              <a:stretch/>
            </p:blipFill>
            <p:spPr>
              <a:xfrm>
                <a:off x="1824120" y="1483560"/>
                <a:ext cx="583920" cy="1603800"/>
              </a:xfrm>
              <a:prstGeom prst="rect">
                <a:avLst/>
              </a:prstGeom>
              <a:ln w="15840">
                <a:solidFill>
                  <a:srgbClr val="000000"/>
                </a:solidFill>
                <a:miter/>
              </a:ln>
            </p:spPr>
          </p:pic>
          <p:pic>
            <p:nvPicPr>
              <p:cNvPr id="119" name="图片 4" descr=""/>
              <p:cNvPicPr/>
              <p:nvPr/>
            </p:nvPicPr>
            <p:blipFill>
              <a:blip r:embed="rId4"/>
              <a:srcRect l="32573" t="32240" r="52195" b="38296"/>
              <a:stretch/>
            </p:blipFill>
            <p:spPr>
              <a:xfrm>
                <a:off x="1818360" y="3162240"/>
                <a:ext cx="589680" cy="760320"/>
              </a:xfrm>
              <a:prstGeom prst="rect">
                <a:avLst/>
              </a:prstGeom>
              <a:ln w="15840">
                <a:solidFill>
                  <a:srgbClr val="000000"/>
                </a:solidFill>
                <a:miter/>
              </a:ln>
            </p:spPr>
          </p:pic>
        </p:grpSp>
        <p:sp>
          <p:nvSpPr>
            <p:cNvPr id="120" name="文本框 122"/>
            <p:cNvSpPr/>
            <p:nvPr/>
          </p:nvSpPr>
          <p:spPr>
            <a:xfrm>
              <a:off x="685800" y="871560"/>
              <a:ext cx="11952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E1+E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MBP-OsPUB4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U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1" name="文本框 162"/>
          <p:cNvSpPr/>
          <p:nvPr/>
        </p:nvSpPr>
        <p:spPr>
          <a:xfrm>
            <a:off x="212760" y="423720"/>
            <a:ext cx="501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文本框 179"/>
          <p:cNvSpPr/>
          <p:nvPr/>
        </p:nvSpPr>
        <p:spPr>
          <a:xfrm>
            <a:off x="3591000" y="449280"/>
            <a:ext cx="501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文本框 51"/>
          <p:cNvSpPr/>
          <p:nvPr/>
        </p:nvSpPr>
        <p:spPr>
          <a:xfrm>
            <a:off x="264960" y="5742000"/>
            <a:ext cx="617220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6.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Ubiquitination assay of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T-OsSKIPa by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MBP-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OsPUB46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.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equal amount of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GST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OsSKIPa was added in the E3 ligase activity reaction. T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he modification of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T-OsSKIPa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was detected by anti-GST, anti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Ub and anti-MBP antibodie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4" name="Picture 1" descr=""/>
          <p:cNvPicPr/>
          <p:nvPr/>
        </p:nvPicPr>
        <p:blipFill>
          <a:blip r:embed="rId1"/>
          <a:stretch/>
        </p:blipFill>
        <p:spPr>
          <a:xfrm>
            <a:off x="1447920" y="457200"/>
            <a:ext cx="2908080" cy="4633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TextBox 1"/>
          <p:cNvSpPr/>
          <p:nvPr/>
        </p:nvSpPr>
        <p:spPr>
          <a:xfrm>
            <a:off x="216000" y="7986600"/>
            <a:ext cx="6553080" cy="128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7. E3 ubiquitin ligase activity of OsRFPH2-10, P3IP1 and OsRING336  </a:t>
            </a: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vitro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a -d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)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The ubiquitination reaction mixtures contained E1 (wheat E1), E2 (AtUBC8), 2 </a:t>
            </a:r>
            <a:r>
              <a:rPr b="0" lang="en-US" sz="1100" spc="-1" strike="noStrike">
                <a:solidFill>
                  <a:srgbClr val="333333"/>
                </a:solidFill>
                <a:latin typeface="Times New Roman"/>
                <a:ea typeface="SimSun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g/</a:t>
            </a:r>
            <a:r>
              <a:rPr b="0" lang="en-US" sz="1100" spc="-1" strike="noStrike">
                <a:solidFill>
                  <a:srgbClr val="333333"/>
                </a:solidFill>
                <a:latin typeface="Times New Roman"/>
                <a:ea typeface="SimSun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L ubiquitin,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ice total extract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preincubated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MBP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P3IP1 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) or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purified MBP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OsRFPH2-10 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), MBP-OsRING336  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c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)  were mixed in a 1 × reaction buffer (50 mM Tris-HCl, pH 7.4, 10 mM MgCl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Times New Roman"/>
                <a:ea typeface="SimSun"/>
              </a:rPr>
              <a:t>2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, 5 mM ATP and 2 mM DTT). The reactions were incubated at 30 ℃ for 2 h,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series of negative controls lacking E1, E2, E3, or ubiquitin (Ub) was used.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In vitro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E3 ligase activity were determined by anti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Ub and anti-MBP.</a:t>
            </a:r>
            <a:r>
              <a:rPr b="0" lang="zh-CN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6" name="Picture 3" descr=""/>
          <p:cNvPicPr/>
          <p:nvPr/>
        </p:nvPicPr>
        <p:blipFill>
          <a:blip r:embed="rId1"/>
          <a:stretch/>
        </p:blipFill>
        <p:spPr>
          <a:xfrm>
            <a:off x="152280" y="304920"/>
            <a:ext cx="6334200" cy="7522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TextBox 1"/>
          <p:cNvSpPr/>
          <p:nvPr/>
        </p:nvSpPr>
        <p:spPr>
          <a:xfrm>
            <a:off x="46080" y="5257800"/>
            <a:ext cx="6553080" cy="179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8. The E3 ubiquitin ligase activity of OsRING116 </a:t>
            </a: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vitro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ubiquitination analysis of rTGA2.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vitro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3 ubiquitin ligase activity assay of OsRING116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ubiquitination reaction mixtures contained E1 (wheat E1), E2 (AtUBC8), 2 </a:t>
            </a:r>
            <a:r>
              <a:rPr b="0" lang="en-US" sz="1100" spc="-1" strike="noStrike">
                <a:solidFill>
                  <a:srgbClr val="333333"/>
                </a:solidFill>
                <a:latin typeface="Times New Roman"/>
                <a:ea typeface="Times New Roman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/</a:t>
            </a:r>
            <a:r>
              <a:rPr b="0" lang="en-US" sz="1100" spc="-1" strike="noStrike">
                <a:solidFill>
                  <a:srgbClr val="333333"/>
                </a:solidFill>
                <a:latin typeface="Times New Roman"/>
                <a:ea typeface="Times New Roman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 ubiquitin, purified GST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sRING116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were mixed in a 1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×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reaction buffer (50 mM Tris-HCl, pH 7.4, 10 mM MgCl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Times New Roman"/>
                <a:ea typeface="SimSun"/>
              </a:rPr>
              <a:t>2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, 5 mM ATP and 2 mM DTT). The reactions were incubated at 30 ℃ for 2 h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series of negative controls lacking E1, E2, E3, or ubiquitin was used. The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in vitro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 E3 ligase activity were determined by anti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Ub and anti-MBP. (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) Ubiquitination assay of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BP-rTGA2.1 by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GST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OsRING116.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he equal amount of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GST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OsRING116 were added in the E3 ligase activity reaction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The modification were detected by anti-GST, anti-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SimSun"/>
              </a:rPr>
              <a:t>Ub and anti-MBP antibodie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8" name="Picture 3" descr=""/>
          <p:cNvPicPr/>
          <p:nvPr/>
        </p:nvPicPr>
        <p:blipFill>
          <a:blip r:embed="rId1"/>
          <a:stretch/>
        </p:blipFill>
        <p:spPr>
          <a:xfrm>
            <a:off x="304920" y="380880"/>
            <a:ext cx="6035400" cy="4017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1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12T21:12:38Z</dcterms:created>
  <dc:creator>laotoo</dc:creator>
  <dc:description/>
  <dc:language>en-US</dc:language>
  <cp:lastModifiedBy>wangr</cp:lastModifiedBy>
  <cp:lastPrinted>2015-06-02T07:19:20Z</cp:lastPrinted>
  <dcterms:modified xsi:type="dcterms:W3CDTF">2022-05-24T09:45:26Z</dcterms:modified>
  <cp:revision>1532</cp:revision>
  <dc:subject/>
  <dc:title>Slide 1</dc:title>
</cp:coreProperties>
</file>